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3" r:id="rId2"/>
    <p:sldId id="264" r:id="rId3"/>
    <p:sldId id="267" r:id="rId4"/>
    <p:sldId id="268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993"/>
    <p:restoredTop sz="87786"/>
  </p:normalViewPr>
  <p:slideViewPr>
    <p:cSldViewPr snapToGrid="0" snapToObjects="1">
      <p:cViewPr>
        <p:scale>
          <a:sx n="210" d="100"/>
          <a:sy n="210" d="100"/>
        </p:scale>
        <p:origin x="14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B99583-F095-8A47-A78B-F54854D94CEE}" type="datetimeFigureOut">
              <a:rPr lang="en-US" smtClean="0"/>
              <a:t>8/2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F7DACB-6670-074C-ACED-A70E58208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49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able 1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F7DACB-6670-074C-ACED-A70E582080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07688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able 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F7DACB-6670-074C-ACED-A70E582080F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1868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op30 </a:t>
            </a:r>
            <a:r>
              <a:rPr lang="en-US" dirty="0" err="1" smtClean="0"/>
              <a:t>mosre</a:t>
            </a:r>
            <a:r>
              <a:rPr lang="en-US" dirty="0" smtClean="0"/>
              <a:t> significant genu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F7DACB-6670-074C-ACED-A70E582080F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5094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op30 </a:t>
            </a:r>
            <a:r>
              <a:rPr lang="en-US" dirty="0" err="1" smtClean="0"/>
              <a:t>mosre</a:t>
            </a:r>
            <a:r>
              <a:rPr lang="en-US" dirty="0" smtClean="0"/>
              <a:t> significant genu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7F7DACB-6670-074C-ACED-A70E582080F5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879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202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209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718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458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712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38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77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77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132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766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946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483B-6538-634D-A878-E0E264B6600B}" type="datetimeFigureOut">
              <a:rPr lang="en-US" smtClean="0"/>
              <a:t>8/2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8BFAFB-D944-5F4E-8F04-F28C559CF9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246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471488" y="2767515"/>
          <a:ext cx="5915026" cy="6023557"/>
        </p:xfrm>
        <a:graphic>
          <a:graphicData uri="http://schemas.openxmlformats.org/drawingml/2006/table">
            <a:tbl>
              <a:tblPr firstRow="1" firstCol="1" bandRow="1"/>
              <a:tblGrid>
                <a:gridCol w="1835698"/>
                <a:gridCol w="1019832"/>
                <a:gridCol w="1019832"/>
                <a:gridCol w="1019832"/>
                <a:gridCol w="1019832"/>
              </a:tblGrid>
              <a:tr h="370006"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xa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label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Tukeys) Dénia-Culler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Tukeys) Vinaròs-Culler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Tukeys) Vinaròs-Déni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robacter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8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96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9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ricoccu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8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4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6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7225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Flammeovirg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5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 dirty="0" err="1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idimonas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75*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78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4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Erythrobacter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85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8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Alphaproteobacteri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9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Cohaesibacter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1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ivulari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6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8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Rhodobacter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7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WD210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9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Chroococcale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5*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8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ewinell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7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75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Trueper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Phyllobacteri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9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9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8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Xenococc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8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GMD14H0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Sphingomonad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8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Flavobacteri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4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Rhodotherm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8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Rhizobiale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hroococcidiopsi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rythrobacter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Phycisphaerale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Pseudanabaen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Jannaschia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aracoccu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At12OctB3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9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treptococcus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6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88494">
                <a:tc>
                  <a:txBody>
                    <a:bodyPr/>
                    <a:lstStyle/>
                    <a:p>
                      <a:pPr algn="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b="1" i="1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Enterobacteriaceae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5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kern="12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5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8543" marR="6854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418594" y="526048"/>
            <a:ext cx="6206263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GB" sz="1200" b="1" dirty="0">
                <a:latin typeface="Palatino Linotype" charset="0"/>
                <a:ea typeface="Calibri" charset="0"/>
                <a:cs typeface="Times New Roman" charset="0"/>
              </a:rPr>
              <a:t>Table 1. </a:t>
            </a:r>
            <a:r>
              <a:rPr lang="en-GB" sz="1200" dirty="0">
                <a:latin typeface="Palatino Linotype" charset="0"/>
                <a:ea typeface="Calibri" charset="0"/>
                <a:cs typeface="Times New Roman" charset="0"/>
              </a:rPr>
              <a:t>Top 30 most abundant genera and p-values for the One-Way ANOVA statistical analysis of their distributions among the three sampled locations. Global p-values and p-values for the comparison by pairs is shown. Significant results are marked by an asterisk.</a:t>
            </a:r>
            <a:endParaRPr lang="en-US" sz="1200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8260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926230"/>
              </p:ext>
            </p:extLst>
          </p:nvPr>
        </p:nvGraphicFramePr>
        <p:xfrm>
          <a:off x="471488" y="4430269"/>
          <a:ext cx="5915024" cy="2698046"/>
        </p:xfrm>
        <a:graphic>
          <a:graphicData uri="http://schemas.openxmlformats.org/drawingml/2006/table">
            <a:tbl>
              <a:tblPr firstRow="1" firstCol="1" bandRow="1"/>
              <a:tblGrid>
                <a:gridCol w="1183490"/>
                <a:gridCol w="2273516"/>
                <a:gridCol w="953468"/>
                <a:gridCol w="1504550"/>
              </a:tblGrid>
              <a:tr h="33926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ample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losest Type Strain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%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</a:t>
                      </a:r>
                      <a:r>
                        <a:rPr lang="en-GB" sz="900" b="1" i="1" baseline="-250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</a:t>
                      </a: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</a:t>
                      </a:r>
                      <a:r>
                        <a:rPr lang="en-GB" sz="900" b="1" i="1" baseline="-250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2 </a:t>
                      </a: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say (dilution at which the isolate remains viable)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0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coccus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ute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CP001628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.77</a:t>
                      </a:r>
                      <a:endParaRPr lang="en-US" sz="90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7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denitrifican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AY543169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.58</a:t>
                      </a:r>
                      <a:endParaRPr lang="en-US" sz="90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7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1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n-identified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en-US" sz="90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2</a:t>
                      </a:r>
                      <a:endParaRPr lang="en-US" sz="1100" dirty="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denitrifican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AY543169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.37</a:t>
                      </a:r>
                      <a:endParaRPr lang="en-US" sz="90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rueperi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AJ310349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.31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6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8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denitrifican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AY543169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6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risflavi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LGUE01000011) 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V44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n-identified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V67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leroni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X82492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.32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4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M10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n-identified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R1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on-identified</a:t>
                      </a:r>
                      <a:endParaRPr lang="en-US" sz="90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R1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s-ES" sz="900" i="1" u="none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</a:t>
                      </a:r>
                      <a:r>
                        <a:rPr lang="es-ES" sz="900" i="1" u="none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s-ES" sz="900" i="1" u="none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ltitudinis</a:t>
                      </a:r>
                      <a:r>
                        <a:rPr lang="es-ES" sz="900" i="1" u="none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s-ES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ASJC011000029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6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R2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coccus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uteus</a:t>
                      </a: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</a:t>
                      </a: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CP001628)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.35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3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ositive control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. </a:t>
                      </a:r>
                      <a:r>
                        <a:rPr lang="en-GB" sz="900" i="1" dirty="0" err="1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laciei</a:t>
                      </a:r>
                      <a:endParaRPr lang="en-US" sz="900" i="1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 </a:t>
                      </a:r>
                      <a:endParaRPr lang="en-US" sz="900" dirty="0"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8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052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b="1" i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egative control</a:t>
                      </a:r>
                      <a:endParaRPr lang="en-US" sz="1100">
                        <a:effectLst/>
                        <a:latin typeface="Calibri" charset="0"/>
                        <a:ea typeface="Calibri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i="1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E. coli </a:t>
                      </a: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(JM109)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 </a:t>
                      </a:r>
                      <a:endParaRPr lang="en-US" sz="90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900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dirty="0"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5547" marR="65547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358039" y="7560944"/>
            <a:ext cx="5885315" cy="7795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600"/>
              </a:spcAft>
            </a:pPr>
            <a:r>
              <a:rPr lang="en-GB" sz="1200" b="1" dirty="0">
                <a:latin typeface="Palatino Linotype" charset="0"/>
                <a:ea typeface="Calibri" charset="0"/>
                <a:cs typeface="Times New Roman" charset="0"/>
              </a:rPr>
              <a:t>Table 2. </a:t>
            </a:r>
            <a:r>
              <a:rPr lang="en-GB" sz="1200" dirty="0">
                <a:latin typeface="Palatino Linotype" charset="0"/>
                <a:ea typeface="Calibri" charset="0"/>
                <a:cs typeface="Times New Roman" charset="0"/>
              </a:rPr>
              <a:t>List of selected isolates, percentage of identity with the closest type strain, sequence similarity and results obtained in the H</a:t>
            </a:r>
            <a:r>
              <a:rPr lang="en-GB" sz="1200" baseline="-25000" dirty="0">
                <a:latin typeface="Palatino Linotype" charset="0"/>
                <a:ea typeface="Calibri" charset="0"/>
                <a:cs typeface="Times New Roman" charset="0"/>
              </a:rPr>
              <a:t>2</a:t>
            </a:r>
            <a:r>
              <a:rPr lang="en-GB" sz="1200" dirty="0">
                <a:latin typeface="Palatino Linotype" charset="0"/>
                <a:ea typeface="Calibri" charset="0"/>
                <a:cs typeface="Times New Roman" charset="0"/>
              </a:rPr>
              <a:t>O</a:t>
            </a:r>
            <a:r>
              <a:rPr lang="en-GB" sz="1200" baseline="-25000" dirty="0">
                <a:latin typeface="Palatino Linotype" charset="0"/>
                <a:ea typeface="Calibri" charset="0"/>
                <a:cs typeface="Times New Roman" charset="0"/>
              </a:rPr>
              <a:t>2</a:t>
            </a:r>
            <a:r>
              <a:rPr lang="en-GB" sz="1200" dirty="0">
                <a:latin typeface="Palatino Linotype" charset="0"/>
                <a:ea typeface="Calibri" charset="0"/>
                <a:cs typeface="Times New Roman" charset="0"/>
              </a:rPr>
              <a:t> assay.</a:t>
            </a:r>
            <a:endParaRPr lang="en-US" sz="1200" dirty="0">
              <a:effectLst/>
              <a:latin typeface="Calibri" charset="0"/>
              <a:ea typeface="Calibri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92635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478212" y="2233471"/>
          <a:ext cx="5915027" cy="5942187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1827959"/>
                <a:gridCol w="1021767"/>
                <a:gridCol w="1021767"/>
                <a:gridCol w="1021767"/>
                <a:gridCol w="1021767"/>
              </a:tblGrid>
              <a:tr h="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ax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abel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ukeys</a:t>
                      </a:r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) 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enia</a:t>
                      </a:r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Culler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ukeys</a:t>
                      </a:r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) 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naros</a:t>
                      </a:r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-Culler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 (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ukeys</a:t>
                      </a:r>
                      <a:r>
                        <a:rPr lang="en-US" sz="900" b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) </a:t>
                      </a:r>
                      <a:r>
                        <a:rPr lang="en-US" sz="900" b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naros-Denia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Flexithrix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037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05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07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Saprospir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2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3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3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06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72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robacter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8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9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09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hodovulum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2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2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2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ricoccu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1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alkalicoccu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39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5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7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caryochlori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39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Flammeovirg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5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taphylococcu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6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ubidimona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7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7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Erythrobacter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08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Acidimicrobiale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2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Pseudoruegeri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7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3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Oceanicell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5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Gammaproteobacteria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3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Alphaproteobacteri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19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7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Cohaesibacter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2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Rivularia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6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TM71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7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laciecola</a:t>
                      </a:r>
                      <a:endParaRPr lang="en-US" sz="900" b="1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7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8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4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lteromona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28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Tunicatimona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aritimibacter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Rhodobacter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7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ynechococcu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7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1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WD2101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39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Chroococcales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45*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ewinell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7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75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Unclassified.Trueperaceae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2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4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5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  <a:tr h="1887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1" i="1" u="none" strike="noStrike" dirty="0" err="1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naerospora</a:t>
                      </a:r>
                      <a:endParaRPr lang="en-US" sz="9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1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06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0.8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6656" marR="6656" marT="6656" marB="0" anchor="ctr"/>
                </a:tc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363070" y="8595410"/>
            <a:ext cx="5936876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able </a:t>
            </a:r>
            <a:r>
              <a:rPr lang="en-GB" sz="900" b="1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S1. </a:t>
            </a:r>
            <a:r>
              <a:rPr lang="en-GB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op </a:t>
            </a:r>
            <a:r>
              <a:rPr lang="en-GB" sz="900" dirty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30 </a:t>
            </a:r>
            <a:r>
              <a:rPr lang="en-GB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most </a:t>
            </a:r>
            <a:r>
              <a:rPr lang="en-GB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ignificant </a:t>
            </a:r>
            <a:r>
              <a:rPr lang="en-GB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genera </a:t>
            </a:r>
            <a:r>
              <a:rPr lang="en-GB" sz="900" dirty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and p-values for the One-Way ANOVA statistical analysis of their distributions among the three sampled locations. Global p-values and p-values for the comparison by pairs is shown. </a:t>
            </a:r>
            <a:r>
              <a:rPr lang="en-GB" sz="900" dirty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ignificant results are marked by an asterisk .</a:t>
            </a:r>
            <a:r>
              <a:rPr lang="en-US" sz="900" dirty="0" smtClean="0"/>
              <a:t> 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1684648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612682" y="369795"/>
          <a:ext cx="4880443" cy="8767981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589043"/>
                <a:gridCol w="1329528"/>
                <a:gridCol w="941014"/>
                <a:gridCol w="1010429"/>
                <a:gridCol w="1010429"/>
              </a:tblGrid>
              <a:tr h="372781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ampl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losest Type Strain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ccession </a:t>
                      </a:r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numbe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ID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GenBank accession numbe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ctr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M1</a:t>
                      </a:r>
                      <a:endParaRPr lang="pt-BR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66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67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faec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66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68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69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69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6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0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6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1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faec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tr-TR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B243865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5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2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8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0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3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9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4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0</a:t>
                      </a:r>
                      <a:endParaRPr lang="da-DK" sz="8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coccus lute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P001628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77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5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1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6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2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7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3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8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4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79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6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0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7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 halodenitrifica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Y5431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58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1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18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2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0</a:t>
                      </a:r>
                      <a:endParaRPr lang="da-DK" sz="8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2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3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2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 halodenitrifica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Y5431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37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4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3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5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4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6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6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7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7</a:t>
                      </a:r>
                      <a:endParaRPr lang="da-DK" sz="8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8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da-DK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28</a:t>
                      </a:r>
                      <a:endParaRPr lang="da-DK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rgibacillus halodenitrifican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Y54316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,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89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1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0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2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licheniform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TCC 14580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9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1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marisflav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GUE01000011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2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4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09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3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5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licheniform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TCC 1458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08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4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marisflav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GUE01000011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,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5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39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31014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0</a:t>
                      </a:r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6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4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Halobacillus trueper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SM 10404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8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7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4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8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45</a:t>
                      </a:r>
                      <a:endParaRPr lang="en-US" sz="800" b="1" i="0" u="none" strike="noStrike" dirty="0">
                        <a:solidFill>
                          <a:srgbClr val="FF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licheniform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E017333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3,20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09999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47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3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1</a:t>
                      </a:r>
                      <a:endParaRPr lang="uk-UA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0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M48</a:t>
                      </a:r>
                      <a:endParaRPr lang="pt-BR" sz="800" b="1" i="0" u="none" strike="noStrike" dirty="0">
                        <a:solidFill>
                          <a:srgbClr val="FF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marisflav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GUE01000011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6,99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1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5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marisflav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LGUE01000011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80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2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R67</a:t>
                      </a:r>
                      <a:endParaRPr lang="is-I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oleroni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X8249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7,32</a:t>
                      </a:r>
                      <a:endParaRPr lang="cs-CZ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3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M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Staphylococcus pasteuri</a:t>
                      </a:r>
                      <a:endParaRPr lang="en-US" sz="800" b="0" i="1" u="none" strike="noStrike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F041361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,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4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R1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</a:t>
                      </a:r>
                      <a:r>
                        <a:rPr lang="en-US" sz="800" i="1" u="none" strike="noStrike" baseline="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sals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24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6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5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DM1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ibrio</a:t>
                      </a:r>
                      <a:r>
                        <a:rPr lang="en-US" sz="800" i="1" u="none" strike="noStrike" baseline="0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 tubiashii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pt-BR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P009354</a:t>
                      </a:r>
                      <a:endParaRPr lang="pt-BR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,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6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R1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Bacillus altitudini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SJC011000029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100,0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7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R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coccus lute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CP001628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35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8</a:t>
                      </a:r>
                    </a:p>
                  </a:txBody>
                  <a:tcPr marL="12700" marR="12700" marT="12700" marB="0" anchor="b"/>
                </a:tc>
              </a:tr>
              <a:tr h="1908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VR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i="1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icrococcus antarcticus</a:t>
                      </a:r>
                      <a:endParaRPr lang="en-US" sz="8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</a:tcPr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AJ005932</a:t>
                      </a:r>
                      <a:endParaRPr lang="is-IS" sz="800" b="0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 dirty="0" smtClean="0"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99,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charset="0"/>
                        <a:ea typeface="Times New Roman" charset="0"/>
                        <a:cs typeface="Times New Roman" charset="0"/>
                      </a:endParaRPr>
                    </a:p>
                  </a:txBody>
                  <a:tcPr marL="12700" marR="12700" marT="12700" marB="0" anchor="b"/>
                </a:tc>
                <a:tc>
                  <a:txBody>
                    <a:bodyPr/>
                    <a:lstStyle/>
                    <a:p>
                      <a:pPr marL="0" marR="0" indent="0" algn="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Times New Roman" charset="0"/>
                          <a:cs typeface="Times New Roman" charset="0"/>
                        </a:rPr>
                        <a:t>MN210009</a:t>
                      </a:r>
                    </a:p>
                  </a:txBody>
                  <a:tcPr marL="12700" marR="12700" marT="12700" marB="0" anchor="b"/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383241" y="9254316"/>
            <a:ext cx="593687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able </a:t>
            </a:r>
            <a:r>
              <a:rPr lang="en-GB" sz="900" b="1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S2.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List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of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trains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identified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in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collectio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,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with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closest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yp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trai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,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accesio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number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, ID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percentag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and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GenBank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accesio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number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for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16S rRNA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equences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.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identificatio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cod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of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trains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corresponds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to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location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from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which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it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was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isolated</a:t>
            </a:r>
            <a:r>
              <a:rPr lang="es-ES" sz="900" dirty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(V: Vinaròs, C: Cullera, D: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Dènia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),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h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sampl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type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 (R: rock, M: marine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water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) and a </a:t>
            </a:r>
            <a:r>
              <a:rPr lang="es-ES" sz="900" dirty="0" err="1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number</a:t>
            </a:r>
            <a:r>
              <a:rPr lang="es-ES" sz="900" dirty="0" smtClean="0">
                <a:highlight>
                  <a:srgbClr val="FFFF00"/>
                </a:highlight>
                <a:latin typeface="Palatino Linotype" charset="0"/>
                <a:ea typeface="Calibri" charset="0"/>
                <a:cs typeface="Times New Roman" charset="0"/>
              </a:rPr>
              <a:t>.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71942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06</TotalTime>
  <Words>1039</Words>
  <Application>Microsoft Macintosh PowerPoint</Application>
  <PresentationFormat>A4 Paper (210x297 mm)</PresentationFormat>
  <Paragraphs>611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74</cp:revision>
  <cp:lastPrinted>2019-07-26T11:22:26Z</cp:lastPrinted>
  <dcterms:created xsi:type="dcterms:W3CDTF">2019-07-10T09:00:14Z</dcterms:created>
  <dcterms:modified xsi:type="dcterms:W3CDTF">2019-08-02T09:08:22Z</dcterms:modified>
</cp:coreProperties>
</file>